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335713" cy="63357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99356-632E-457C-A6F2-135392EAF0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57024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3663000"/>
            <a:ext cx="57024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50BB8-929E-494C-A2DC-166B740875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36630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36630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E05AC-0BF1-42F3-916A-C1E26DB838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14778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14778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36630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36630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3663000"/>
            <a:ext cx="18360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22F97-6944-4128-A2F0-CE4E71DBE0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1477800"/>
            <a:ext cx="5702400" cy="418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72D12-F09D-49C8-8872-B20229F225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570240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6D338-7C70-4E17-A27B-019472DF26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278244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1477800"/>
            <a:ext cx="278244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9DB09-7B1A-4107-9432-B3D73E54F2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A0105-6521-4D59-8990-1150614776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254160"/>
            <a:ext cx="5702400" cy="4894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EB81F-FA47-4613-97A3-6AEDA2CE35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1477800"/>
            <a:ext cx="278244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36630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2A4BF-404D-4823-89A7-BE63D01ACB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278244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36630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D7F40-2763-44C3-8B69-C8CA1BECD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1477800"/>
            <a:ext cx="278244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3663000"/>
            <a:ext cx="5702400" cy="19951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AF031-8245-4475-A35B-F326601710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254160"/>
            <a:ext cx="5702400" cy="105552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1477800"/>
            <a:ext cx="5702400" cy="418320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rmAutofit/>
          </a:bodyPr>
          <a:p>
            <a:pPr marL="271440" indent="-27144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588960" indent="-22716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905040" indent="-181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266840" indent="-18108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1628640" indent="-1807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1628640" indent="-1807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1628640" indent="-18072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5770440"/>
            <a:ext cx="1477800" cy="44136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Autofit/>
          </a:bodyPr>
          <a:lstStyle>
            <a:lvl1pPr indent="0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5770440"/>
            <a:ext cx="2006640" cy="44136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Autofit/>
          </a:bodyPr>
          <a:lstStyle>
            <a:lvl1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5770440"/>
            <a:ext cx="1478160" cy="441360"/>
          </a:xfrm>
          <a:prstGeom prst="rect">
            <a:avLst/>
          </a:prstGeom>
          <a:noFill/>
          <a:ln w="0">
            <a:noFill/>
          </a:ln>
        </p:spPr>
        <p:txBody>
          <a:bodyPr lIns="72360" rIns="72360" tIns="36360" bIns="36360" anchor="t">
            <a:noAutofit/>
          </a:bodyPr>
          <a:lstStyle>
            <a:lvl1pPr indent="0" algn="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410760"/>
                <a:tab algn="l" pos="10134720"/>
                <a:tab algn="l" pos="10858680"/>
              </a:tabLst>
            </a:pPr>
            <a:fld id="{9558F866-D4B8-4373-AFA1-84BF72AB4685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8960" y="73080"/>
            <a:ext cx="6215040" cy="6190920"/>
            <a:chOff x="48960" y="73080"/>
            <a:chExt cx="6215040" cy="6190920"/>
          </a:xfrm>
        </p:grpSpPr>
        <p:sp>
          <p:nvSpPr>
            <p:cNvPr id="42" name=""/>
            <p:cNvSpPr/>
            <p:nvPr/>
          </p:nvSpPr>
          <p:spPr>
            <a:xfrm>
              <a:off x="2503440" y="5709600"/>
              <a:ext cx="66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opla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106800" y="5709600"/>
              <a:ext cx="975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Arabidop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394720" y="5647320"/>
              <a:ext cx="693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3156480" y="5645520"/>
              <a:ext cx="71496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54240" y="5647320"/>
              <a:ext cx="691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13280" y="5709600"/>
              <a:ext cx="421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i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726800" y="5647320"/>
              <a:ext cx="693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646160" y="5709600"/>
              <a:ext cx="79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i="1" lang="en-AU" sz="800" spc="-1" strike="noStrike">
                  <a:solidFill>
                    <a:srgbClr val="000000"/>
                  </a:solidFill>
                  <a:latin typeface="Arial"/>
                </a:rPr>
                <a:t>Selaginel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488560" y="5647320"/>
              <a:ext cx="693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608080" y="5709600"/>
              <a:ext cx="65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83800" y="5709600"/>
              <a:ext cx="66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i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629720" y="5709600"/>
              <a:ext cx="623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ru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775080" y="5645520"/>
              <a:ext cx="76464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1608120" y="5645520"/>
              <a:ext cx="71496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1"/>
            <a:srcRect l="23059" t="84146" r="14050" b="2078"/>
            <a:stretch/>
          </p:blipFill>
          <p:spPr>
            <a:xfrm>
              <a:off x="1620720" y="5878440"/>
              <a:ext cx="3869280" cy="385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"/>
            <p:cNvSpPr/>
            <p:nvPr/>
          </p:nvSpPr>
          <p:spPr>
            <a:xfrm>
              <a:off x="48960" y="7308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8960" y="138636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9680" y="26712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9680" y="39578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" descr=""/>
            <p:cNvPicPr/>
            <p:nvPr/>
          </p:nvPicPr>
          <p:blipFill>
            <a:blip r:embed="rId2"/>
            <a:srcRect l="4672" t="0" r="0" b="32319"/>
            <a:stretch/>
          </p:blipFill>
          <p:spPr>
            <a:xfrm>
              <a:off x="424440" y="201960"/>
              <a:ext cx="5769720" cy="126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" descr=""/>
            <p:cNvPicPr/>
            <p:nvPr/>
          </p:nvPicPr>
          <p:blipFill>
            <a:blip r:embed="rId3"/>
            <a:srcRect l="4184" t="0" r="0" b="32350"/>
            <a:stretch/>
          </p:blipFill>
          <p:spPr>
            <a:xfrm>
              <a:off x="424440" y="1498320"/>
              <a:ext cx="5769720" cy="125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4"/>
            <a:srcRect l="4874" t="0" r="0" b="32377"/>
            <a:stretch/>
          </p:blipFill>
          <p:spPr>
            <a:xfrm>
              <a:off x="424440" y="2814840"/>
              <a:ext cx="5769720" cy="122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" descr=""/>
            <p:cNvPicPr/>
            <p:nvPr/>
          </p:nvPicPr>
          <p:blipFill>
            <a:blip r:embed="rId5"/>
            <a:srcRect l="4879" t="0" r="0" b="18252"/>
            <a:stretch/>
          </p:blipFill>
          <p:spPr>
            <a:xfrm>
              <a:off x="424440" y="4102560"/>
              <a:ext cx="5769720" cy="147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"/>
            <p:cNvSpPr/>
            <p:nvPr/>
          </p:nvSpPr>
          <p:spPr>
            <a:xfrm>
              <a:off x="4715640" y="305640"/>
              <a:ext cx="126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Radiata pi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787280" y="1528200"/>
              <a:ext cx="126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oblolly pi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856760" y="2813040"/>
              <a:ext cx="126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hite spru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856760" y="4114080"/>
              <a:ext cx="126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opla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7T04:51:15Z</dcterms:created>
  <dc:creator>Li, Xinguo (PI, Black Mountain)</dc:creator>
  <dc:description/>
  <dc:language>en-US</dc:language>
  <cp:lastModifiedBy>Li, Xinguo (PI, Black Mountain)</cp:lastModifiedBy>
  <dcterms:modified xsi:type="dcterms:W3CDTF">2009-09-30T07:41:09Z</dcterms:modified>
  <cp:revision>3</cp:revision>
  <dc:subject/>
  <dc:title>Slide 1</dc:title>
</cp:coreProperties>
</file>